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2800ED-8C37-DF01-CA2E-6BF4390AC2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B77B22-6F60-762B-375E-D677720F52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ED34F3-E5D9-FFEB-DF80-AC088C474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0AE273-F830-D131-7D0F-98FAB0FB5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5072F5-ECB9-8B48-CCA9-BE78C2293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591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16830-5871-D979-00BB-79D9460E13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FF715F-A15C-64CC-629C-C5FCF18044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61857-B1B3-68A0-DD81-6B496607C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B7B66-9D29-F936-EAFD-892B0C9BE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4046FB-BDA0-1300-3F87-5AD46303D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873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BC73EE-F593-976B-25CE-FA4EBD9E8C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BFD76D-7ADE-0BB3-6F8E-A39F4CC643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2FCCE8-30C7-F58C-03D5-7EE82E8D2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FF8B7-FC87-BFD0-7B7E-AEDC76C78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70ABD7-5A48-FB0B-979B-672CD535C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099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84F13-4C53-E80C-C513-AD2ED2F7D3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66425E-EFF3-3AA0-5164-D7BA373F86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2FB51-0195-EC53-CE8A-1EE3CD3D9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37C69-95AA-8719-4C01-612941465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46BF60-5DFC-F2A0-F2D8-79C6B3696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286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A4179-DCC7-A0A5-1501-2FC7BA923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BAFB4C-60E2-3B00-5F68-2766488B3C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74801-8627-CBA4-6859-D3DA7404F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F81E4B-F4E1-2B3E-6E73-9ECFFA816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10A7AB-CF0D-F118-A8C8-E86391D46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730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3D098C-1FA5-7E87-B50D-F8FA46415E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3F073F-4525-5BFB-3E0D-A6F55048C4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ED58A8-C197-5446-207F-F515EB63C0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4ADA52-44D7-D16F-A7ED-5798F718E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5A97A6-73F1-0AF6-723C-4653E9E0C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C0C399-08D2-545F-F012-7B900BC5E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872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194D5-A2E3-E5DA-FAEA-0D17842A4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0431DC-B05D-17E8-0428-97A2887919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1F8B85-1F36-F57C-10B1-EBA460DA6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A4C7C7-BBFA-4AC3-D52F-C2A11B60E8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BF4BEE-9A20-272F-BBFE-D8EFEA100D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48BB367-2CD2-529B-7CC3-5A1288216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0CF857-509F-2ABF-EF69-91701A013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D727E2-A7B6-DE59-8E0A-0087D3CD1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847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14509-81B1-C6C7-0C7C-2561A4CDDC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8A73AA-5C92-1F44-1A44-3288EAF16C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F7C693-9C2D-338D-EED4-996F488C2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3A0E3D-8A1B-F4EA-C0E6-6B5FE9CCD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955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C19DBE-131E-3074-D461-8F6A49904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F0F24E-97C6-D821-52AE-547F2120A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8DCDCB-18BD-5D7B-82CE-6A9951B8E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756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0407D-9856-574E-0496-B64A10DDDF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94A706-5623-3257-4EDE-E232637D5C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CB23AD-2B3B-A6A3-326A-F3AF12C9B0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8AF2F4-19EA-C3A2-DD89-314BCDD1A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F67009-15DF-20E9-4F34-C93E4127F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D6BDE5-4FDC-0DB5-68C6-D55A0EF7E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35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98E54-9CBF-598D-2D1A-983F06E69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3AE3D3-5D29-F8FD-6E8C-D10DDA2F71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81E59A-7583-8B65-4C71-B274E7B2E4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D769EF-48B4-55E3-1FA3-61C4F5F53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069714-0AF5-6239-EFF0-77129D4DE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21B736-CDA2-6F5D-FFE5-FBF089C02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187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F050CD1-06DB-B4F7-061F-113100E4D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430F92-537E-E419-FF28-D1AFB6B05B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853F4F-A392-12F3-8DCC-3CBD492CFC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F04BF-459B-4355-8108-8F64ABC3C152}" type="datetimeFigureOut">
              <a:rPr lang="en-US" smtClean="0"/>
              <a:t>7/3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A42013-98E0-F970-F7C6-6A057FE5C5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046537-A041-BB76-56C4-095CBFEC86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321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8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E88D418-C78F-B3E5-A747-179FBF073FFC}"/>
              </a:ext>
            </a:extLst>
          </p:cNvPr>
          <p:cNvGrpSpPr/>
          <p:nvPr/>
        </p:nvGrpSpPr>
        <p:grpSpPr>
          <a:xfrm>
            <a:off x="126264" y="104290"/>
            <a:ext cx="5736055" cy="6418897"/>
            <a:chOff x="969544" y="144691"/>
            <a:chExt cx="5736055" cy="641889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57559518-B795-1D75-874C-6ADDACAF9B69}"/>
                </a:ext>
              </a:extLst>
            </p:cNvPr>
            <p:cNvGrpSpPr/>
            <p:nvPr/>
          </p:nvGrpSpPr>
          <p:grpSpPr>
            <a:xfrm>
              <a:off x="969544" y="144691"/>
              <a:ext cx="5736055" cy="5296918"/>
              <a:chOff x="992585" y="150566"/>
              <a:chExt cx="6213043" cy="5903301"/>
            </a:xfrm>
          </p:grpSpPr>
          <p:pic>
            <p:nvPicPr>
              <p:cNvPr id="10" name="Picture 9" descr="A close-up of a person's eye&#10;&#10;Description automatically generated with low confidence">
                <a:extLst>
                  <a:ext uri="{FF2B5EF4-FFF2-40B4-BE49-F238E27FC236}">
                    <a16:creationId xmlns:a16="http://schemas.microsoft.com/office/drawing/2014/main" id="{03F557D0-BA23-85C8-E8E1-DE5179BEC3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67000" contrast="-1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81294" y="4863220"/>
                <a:ext cx="1190647" cy="1190647"/>
              </a:xfrm>
              <a:prstGeom prst="rect">
                <a:avLst/>
              </a:prstGeom>
            </p:spPr>
          </p:pic>
          <p:pic>
            <p:nvPicPr>
              <p:cNvPr id="11" name="Picture 10" descr="A close-up of a person's chest&#10;&#10;Description automatically generated with low confidence">
                <a:extLst>
                  <a:ext uri="{FF2B5EF4-FFF2-40B4-BE49-F238E27FC236}">
                    <a16:creationId xmlns:a16="http://schemas.microsoft.com/office/drawing/2014/main" id="{A1E6E6E2-EA54-E450-9F2C-DA65CF83AE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60000" contrast="-1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425072" y="4863220"/>
                <a:ext cx="1190647" cy="1190647"/>
              </a:xfrm>
              <a:prstGeom prst="rect">
                <a:avLst/>
              </a:prstGeom>
            </p:spPr>
          </p:pic>
          <p:pic>
            <p:nvPicPr>
              <p:cNvPr id="12" name="Picture 11" descr="A picture containing black, dark, orange, close&#10;&#10;Description automatically generated">
                <a:extLst>
                  <a:ext uri="{FF2B5EF4-FFF2-40B4-BE49-F238E27FC236}">
                    <a16:creationId xmlns:a16="http://schemas.microsoft.com/office/drawing/2014/main" id="{175EEB7B-F58C-E26E-031D-6952011E04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aturation sat="72000"/>
                        </a14:imgEffect>
                        <a14:imgEffect>
                          <a14:brightnessContrast bright="1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70312" y="4858087"/>
                <a:ext cx="1174633" cy="1195780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4FF19F5-B0C6-538D-9C23-79D820D8F4F2}"/>
                  </a:ext>
                </a:extLst>
              </p:cNvPr>
              <p:cNvSpPr txBox="1"/>
              <p:nvPr/>
            </p:nvSpPr>
            <p:spPr>
              <a:xfrm>
                <a:off x="1184751" y="5067742"/>
                <a:ext cx="1038665" cy="926128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Mid Dose Treated</a:t>
                </a:r>
              </a:p>
              <a:p>
                <a:pPr algn="ctr"/>
                <a:r>
                  <a:rPr lang="en-US" sz="1200" b="1" i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Rho</a:t>
                </a:r>
                <a:r>
                  <a:rPr lang="en-US" sz="1200" b="1" i="1" baseline="30000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P23H+/-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4520A9FC-C2C6-1C54-898D-343ECD474C1E}"/>
                  </a:ext>
                </a:extLst>
              </p:cNvPr>
              <p:cNvGrpSpPr/>
              <p:nvPr/>
            </p:nvGrpSpPr>
            <p:grpSpPr>
              <a:xfrm>
                <a:off x="992585" y="150566"/>
                <a:ext cx="6213043" cy="4656326"/>
                <a:chOff x="992585" y="778632"/>
                <a:chExt cx="6213043" cy="4656326"/>
              </a:xfrm>
            </p:grpSpPr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8B5A5015-868F-0256-436D-CB5C16616338}"/>
                    </a:ext>
                  </a:extLst>
                </p:cNvPr>
                <p:cNvSpPr txBox="1"/>
                <p:nvPr/>
              </p:nvSpPr>
              <p:spPr>
                <a:xfrm>
                  <a:off x="3303091" y="789374"/>
                  <a:ext cx="1430690" cy="514516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6 Control</a:t>
                  </a:r>
                </a:p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Month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F1DCF768-7A9F-FB5B-758D-A11FD2CE1185}"/>
                    </a:ext>
                  </a:extLst>
                </p:cNvPr>
                <p:cNvSpPr txBox="1"/>
                <p:nvPr/>
              </p:nvSpPr>
              <p:spPr>
                <a:xfrm>
                  <a:off x="2061273" y="2688760"/>
                  <a:ext cx="1430690" cy="308709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 Months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2E7FB0FE-E8C6-0610-8ABE-6BCD2CAE6357}"/>
                    </a:ext>
                  </a:extLst>
                </p:cNvPr>
                <p:cNvSpPr txBox="1"/>
                <p:nvPr/>
              </p:nvSpPr>
              <p:spPr>
                <a:xfrm>
                  <a:off x="3303091" y="2676407"/>
                  <a:ext cx="1430690" cy="308709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 Months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255A423F-434F-9C44-0240-298E2BC2504F}"/>
                    </a:ext>
                  </a:extLst>
                </p:cNvPr>
                <p:cNvSpPr txBox="1"/>
                <p:nvPr/>
              </p:nvSpPr>
              <p:spPr>
                <a:xfrm>
                  <a:off x="4541287" y="2675092"/>
                  <a:ext cx="1430690" cy="308709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 Months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3F835A96-C8B3-B224-F2D7-B394266EFC7F}"/>
                    </a:ext>
                  </a:extLst>
                </p:cNvPr>
                <p:cNvSpPr txBox="1"/>
                <p:nvPr/>
              </p:nvSpPr>
              <p:spPr>
                <a:xfrm>
                  <a:off x="1646786" y="827538"/>
                  <a:ext cx="510397" cy="3773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.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DFE2BB3A-5545-65FC-3CD9-111F5FFCCEA8}"/>
                    </a:ext>
                  </a:extLst>
                </p:cNvPr>
                <p:cNvSpPr txBox="1"/>
                <p:nvPr/>
              </p:nvSpPr>
              <p:spPr>
                <a:xfrm>
                  <a:off x="2312210" y="803819"/>
                  <a:ext cx="942672" cy="514516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i="1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Rho</a:t>
                  </a:r>
                  <a:r>
                    <a:rPr lang="en-US" sz="1200" b="1" i="1" baseline="30000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P23H+/-</a:t>
                  </a:r>
                  <a:r>
                    <a:rPr lang="en-US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Month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B2AC78AB-6D93-E3E3-38D8-B464D93BF575}"/>
                    </a:ext>
                  </a:extLst>
                </p:cNvPr>
                <p:cNvSpPr txBox="1"/>
                <p:nvPr/>
              </p:nvSpPr>
              <p:spPr>
                <a:xfrm>
                  <a:off x="4539993" y="778632"/>
                  <a:ext cx="1430690" cy="514516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6 Control</a:t>
                  </a:r>
                </a:p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 Months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3A551D55-33DA-4C75-62D1-F00C6613D56C}"/>
                    </a:ext>
                  </a:extLst>
                </p:cNvPr>
                <p:cNvSpPr txBox="1"/>
                <p:nvPr/>
              </p:nvSpPr>
              <p:spPr>
                <a:xfrm>
                  <a:off x="5774938" y="778633"/>
                  <a:ext cx="1430690" cy="514516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6 Control</a:t>
                  </a:r>
                </a:p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 Months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180870E2-AF66-F991-D9F8-8EFEE5E47FBA}"/>
                    </a:ext>
                  </a:extLst>
                </p:cNvPr>
                <p:cNvSpPr txBox="1"/>
                <p:nvPr/>
              </p:nvSpPr>
              <p:spPr>
                <a:xfrm>
                  <a:off x="1624776" y="2623339"/>
                  <a:ext cx="510397" cy="3773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.</a:t>
                  </a:r>
                </a:p>
              </p:txBody>
            </p:sp>
            <p:pic>
              <p:nvPicPr>
                <p:cNvPr id="24" name="Picture 23" descr="A picture containing indoor, fruit, black, dark&#10;&#10;Description automatically generated">
                  <a:extLst>
                    <a:ext uri="{FF2B5EF4-FFF2-40B4-BE49-F238E27FC236}">
                      <a16:creationId xmlns:a16="http://schemas.microsoft.com/office/drawing/2014/main" id="{E94C2102-9FCD-4CE0-F528-9BC0106143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hq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59000"/>
                          </a14:imgEffect>
                          <a14:imgEffect>
                            <a14:brightnessContrast bright="63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90127" y="1314431"/>
                  <a:ext cx="1190647" cy="1190647"/>
                </a:xfrm>
                <a:prstGeom prst="rect">
                  <a:avLst/>
                </a:prstGeom>
              </p:spPr>
            </p:pic>
            <p:pic>
              <p:nvPicPr>
                <p:cNvPr id="25" name="Picture 24" descr="A picture containing text, black, fruit, dark&#10;&#10;Description automatically generated">
                  <a:extLst>
                    <a:ext uri="{FF2B5EF4-FFF2-40B4-BE49-F238E27FC236}">
                      <a16:creationId xmlns:a16="http://schemas.microsoft.com/office/drawing/2014/main" id="{BA975159-2A32-4281-0B7B-DE0BB4155E2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hqprint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sharpenSoften amount="46000"/>
                          </a14:imgEffect>
                          <a14:imgEffect>
                            <a14:brightnessContrast bright="43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25072" y="1306211"/>
                  <a:ext cx="1190647" cy="1190647"/>
                </a:xfrm>
                <a:prstGeom prst="rect">
                  <a:avLst/>
                </a:prstGeom>
              </p:spPr>
            </p:pic>
            <p:pic>
              <p:nvPicPr>
                <p:cNvPr id="26" name="Picture 25" descr="A picture containing indoor, fruit, dark, apple&#10;&#10;Description automatically generated">
                  <a:extLst>
                    <a:ext uri="{FF2B5EF4-FFF2-40B4-BE49-F238E27FC236}">
                      <a16:creationId xmlns:a16="http://schemas.microsoft.com/office/drawing/2014/main" id="{FE2A78BB-65C0-D3BA-71CD-694CDDF95DC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 cstate="hqprint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sharpenSoften amount="55000"/>
                          </a14:imgEffect>
                          <a14:imgEffect>
                            <a14:brightnessContrast bright="59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660017" y="1306211"/>
                  <a:ext cx="1190647" cy="1190647"/>
                </a:xfrm>
                <a:prstGeom prst="rect">
                  <a:avLst/>
                </a:prstGeom>
              </p:spPr>
            </p:pic>
            <p:pic>
              <p:nvPicPr>
                <p:cNvPr id="27" name="Picture 26" descr="A picture containing indoor, dark&#10;&#10;Description automatically generated">
                  <a:extLst>
                    <a:ext uri="{FF2B5EF4-FFF2-40B4-BE49-F238E27FC236}">
                      <a16:creationId xmlns:a16="http://schemas.microsoft.com/office/drawing/2014/main" id="{B7641E30-4E64-4210-1341-F0E5CBBC5DC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 cstate="hqprint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sharpenSoften amount="56000"/>
                          </a14:imgEffect>
                          <a14:imgEffect>
                            <a14:brightnessContrast bright="52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82120" y="2990446"/>
                  <a:ext cx="1190647" cy="1190648"/>
                </a:xfrm>
                <a:prstGeom prst="rect">
                  <a:avLst/>
                </a:prstGeom>
              </p:spPr>
            </p:pic>
            <p:pic>
              <p:nvPicPr>
                <p:cNvPr id="28" name="Picture 27" descr="A picture containing text, black, dark&#10;&#10;Description automatically generated">
                  <a:extLst>
                    <a:ext uri="{FF2B5EF4-FFF2-40B4-BE49-F238E27FC236}">
                      <a16:creationId xmlns:a16="http://schemas.microsoft.com/office/drawing/2014/main" id="{2EAAC792-3261-684D-793B-3EC32083B7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 cstate="hqprint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sharpenSoften amount="48000"/>
                          </a14:imgEffect>
                          <a14:imgEffect>
                            <a14:brightnessContrast bright="57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81373" y="4232989"/>
                  <a:ext cx="1190647" cy="1190647"/>
                </a:xfrm>
                <a:prstGeom prst="rect">
                  <a:avLst/>
                </a:prstGeom>
              </p:spPr>
            </p:pic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F956AB18-9B4B-EB9D-37D8-38D878E5800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 cstate="hqprint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sharpenSoften amount="55000"/>
                          </a14:imgEffect>
                          <a14:imgEffect>
                            <a14:brightnessContrast bright="73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24113" y="3000422"/>
                  <a:ext cx="1190647" cy="1190647"/>
                </a:xfrm>
                <a:prstGeom prst="rect">
                  <a:avLst/>
                </a:prstGeom>
              </p:spPr>
            </p:pic>
            <p:pic>
              <p:nvPicPr>
                <p:cNvPr id="30" name="Picture 29" descr="A picture containing indoor, black, orange, dark&#10;&#10;Description automatically generated">
                  <a:extLst>
                    <a:ext uri="{FF2B5EF4-FFF2-40B4-BE49-F238E27FC236}">
                      <a16:creationId xmlns:a16="http://schemas.microsoft.com/office/drawing/2014/main" id="{0632F541-E745-FEF8-88BB-C58B4242D57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0" cstate="hqprint">
                  <a:extLst>
                    <a:ext uri="{BEBA8EAE-BF5A-486C-A8C5-ECC9F3942E4B}">
                      <a14:imgProps xmlns:a14="http://schemas.microsoft.com/office/drawing/2010/main">
                        <a14:imgLayer r:embed="rId21">
                          <a14:imgEffect>
                            <a14:sharpenSoften amount="50000"/>
                          </a14:imgEffect>
                          <a14:imgEffect>
                            <a14:saturation sat="88000"/>
                          </a14:imgEffect>
                          <a14:imgEffect>
                            <a14:brightnessContrast bright="67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24113" y="4240762"/>
                  <a:ext cx="1190647" cy="1190648"/>
                </a:xfrm>
                <a:prstGeom prst="rect">
                  <a:avLst/>
                </a:prstGeom>
              </p:spPr>
            </p:pic>
            <p:pic>
              <p:nvPicPr>
                <p:cNvPr id="31" name="Picture 30" descr="A picture containing text, indoor, orange, dark&#10;&#10;Description automatically generated">
                  <a:extLst>
                    <a:ext uri="{FF2B5EF4-FFF2-40B4-BE49-F238E27FC236}">
                      <a16:creationId xmlns:a16="http://schemas.microsoft.com/office/drawing/2014/main" id="{BBF37BF0-9C8B-60C3-3860-8EE5E1E7AB9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 cstate="hqprint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sharpenSoften amount="41000"/>
                          </a14:imgEffect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676032" y="4249998"/>
                  <a:ext cx="1174633" cy="1184960"/>
                </a:xfrm>
                <a:prstGeom prst="rect">
                  <a:avLst/>
                </a:prstGeom>
              </p:spPr>
            </p:pic>
            <p:pic>
              <p:nvPicPr>
                <p:cNvPr id="32" name="Picture 31" descr="A picture containing apple, fruit, indoor, black&#10;&#10;Description automatically generated">
                  <a:extLst>
                    <a:ext uri="{FF2B5EF4-FFF2-40B4-BE49-F238E27FC236}">
                      <a16:creationId xmlns:a16="http://schemas.microsoft.com/office/drawing/2014/main" id="{1BF65DF9-FED4-092A-90AE-1952B3443D0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 cstate="hqprint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colorTemperature colorTemp="8525"/>
                          </a14:imgEffect>
                          <a14:imgEffect>
                            <a14:saturation sat="99000"/>
                          </a14:imgEffect>
                          <a14:imgEffect>
                            <a14:brightnessContrast bright="29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94962" y="1306210"/>
                  <a:ext cx="1190647" cy="1190647"/>
                </a:xfrm>
                <a:prstGeom prst="rect">
                  <a:avLst/>
                </a:prstGeom>
              </p:spPr>
            </p:pic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3AE5E206-46B6-8DF7-7E0E-ECF3EEADC562}"/>
                    </a:ext>
                  </a:extLst>
                </p:cNvPr>
                <p:cNvSpPr txBox="1"/>
                <p:nvPr/>
              </p:nvSpPr>
              <p:spPr>
                <a:xfrm>
                  <a:off x="992585" y="3327142"/>
                  <a:ext cx="1430691" cy="720322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Untreated</a:t>
                  </a:r>
                </a:p>
                <a:p>
                  <a:pPr algn="ctr"/>
                  <a:r>
                    <a:rPr lang="en-US" sz="1200" b="1" i="1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Rho</a:t>
                  </a:r>
                  <a:r>
                    <a:rPr lang="en-US" sz="1200" b="1" i="1" baseline="30000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P23H+/-</a:t>
                  </a:r>
                  <a:endPara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C9A695B9-A909-4D02-B578-814411565C3A}"/>
                    </a:ext>
                  </a:extLst>
                </p:cNvPr>
                <p:cNvSpPr txBox="1"/>
                <p:nvPr/>
              </p:nvSpPr>
              <p:spPr>
                <a:xfrm>
                  <a:off x="1064706" y="4443106"/>
                  <a:ext cx="1286695" cy="926128"/>
                </a:xfrm>
                <a:prstGeom prst="rect">
                  <a:avLst/>
                </a:prstGeom>
                <a:noFill/>
              </p:spPr>
              <p:txBody>
                <a:bodyPr wrap="square" lIns="91440" tIns="45720" rIns="91440" bIns="45720" rtlCol="0" anchor="t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Low Dose Treated</a:t>
                  </a:r>
                </a:p>
                <a:p>
                  <a:pPr algn="ctr"/>
                  <a:r>
                    <a:rPr lang="en-US" sz="1200" b="1" i="1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Rho</a:t>
                  </a:r>
                  <a:r>
                    <a:rPr lang="en-US" sz="1200" b="1" i="1" baseline="30000" dirty="0">
                      <a:latin typeface="Times New Roman" panose="02020603050405020304" pitchFamily="18" charset="0"/>
                      <a:ea typeface="+mn-lt"/>
                      <a:cs typeface="Times New Roman" panose="02020603050405020304" pitchFamily="18" charset="0"/>
                    </a:rPr>
                    <a:t>P23H+/-</a:t>
                  </a:r>
                  <a:endPara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endPara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35" name="Picture 34" descr="A picture containing text, apple, indoor, dark&#10;&#10;Description automatically generated">
                  <a:extLst>
                    <a:ext uri="{FF2B5EF4-FFF2-40B4-BE49-F238E27FC236}">
                      <a16:creationId xmlns:a16="http://schemas.microsoft.com/office/drawing/2014/main" id="{032A5375-5D0A-7933-9AFC-1AB4326C64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 cstate="hqprint">
                  <a:extLst>
                    <a:ext uri="{BEBA8EAE-BF5A-486C-A8C5-ECC9F3942E4B}">
                      <a14:imgProps xmlns:a14="http://schemas.microsoft.com/office/drawing/2010/main">
                        <a14:imgLayer r:embed="rId27">
                          <a14:imgEffect>
                            <a14:saturation sat="76000"/>
                          </a14:imgEffect>
                          <a14:imgEffect>
                            <a14:brightnessContrast bright="34000" contrast="4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676032" y="3000423"/>
                  <a:ext cx="1174633" cy="1196474"/>
                </a:xfrm>
                <a:prstGeom prst="rect">
                  <a:avLst/>
                </a:prstGeom>
              </p:spPr>
            </p:pic>
          </p:grpSp>
        </p:grpSp>
        <p:pic>
          <p:nvPicPr>
            <p:cNvPr id="6" name="Picture 5" descr="A picture containing indoor, dark, black, orange&#10;&#10;Description automatically generated">
              <a:extLst>
                <a:ext uri="{FF2B5EF4-FFF2-40B4-BE49-F238E27FC236}">
                  <a16:creationId xmlns:a16="http://schemas.microsoft.com/office/drawing/2014/main" id="{9F325824-3705-39A5-4B7B-BD6C3AE0472F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 cstate="hq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61000" contrast="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066994" y="5495149"/>
              <a:ext cx="1100002" cy="1068346"/>
            </a:xfrm>
            <a:prstGeom prst="rect">
              <a:avLst/>
            </a:prstGeom>
          </p:spPr>
        </p:pic>
        <p:pic>
          <p:nvPicPr>
            <p:cNvPr id="7" name="Picture 6" descr="A picture containing indoor, fruit, dark, black&#10;&#10;Description automatically generated">
              <a:extLst>
                <a:ext uri="{FF2B5EF4-FFF2-40B4-BE49-F238E27FC236}">
                  <a16:creationId xmlns:a16="http://schemas.microsoft.com/office/drawing/2014/main" id="{DC92B5BF-086F-917E-9991-1C4FB20808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 cstate="hq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4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18750" y="5495688"/>
              <a:ext cx="1099239" cy="1067807"/>
            </a:xfrm>
            <a:prstGeom prst="rect">
              <a:avLst/>
            </a:prstGeom>
          </p:spPr>
        </p:pic>
        <p:pic>
          <p:nvPicPr>
            <p:cNvPr id="8" name="Picture 7" descr="A picture containing text, indoor, black, dark&#10;&#10;Description automatically generated">
              <a:extLst>
                <a:ext uri="{FF2B5EF4-FFF2-40B4-BE49-F238E27FC236}">
                  <a16:creationId xmlns:a16="http://schemas.microsoft.com/office/drawing/2014/main" id="{F22039B4-2963-1B77-7158-0B1859D1A0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 cstate="hq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1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370206" y="5495780"/>
              <a:ext cx="1079173" cy="1067808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AB323FF-BB8A-56B1-3FAB-B0C7D6D9F94D}"/>
                </a:ext>
              </a:extLst>
            </p:cNvPr>
            <p:cNvSpPr txBox="1"/>
            <p:nvPr/>
          </p:nvSpPr>
          <p:spPr>
            <a:xfrm>
              <a:off x="1065480" y="5651155"/>
              <a:ext cx="1100002" cy="830997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ea typeface="+mn-lt"/>
                  <a:cs typeface="Times New Roman" panose="02020603050405020304" pitchFamily="18" charset="0"/>
                </a:rPr>
                <a:t>High Dose Treated</a:t>
              </a:r>
            </a:p>
            <a:p>
              <a:pPr algn="ctr"/>
              <a:r>
                <a:rPr lang="en-US" sz="1200" b="1" i="1" dirty="0">
                  <a:latin typeface="Times New Roman" panose="02020603050405020304" pitchFamily="18" charset="0"/>
                  <a:ea typeface="+mn-lt"/>
                  <a:cs typeface="Times New Roman" panose="02020603050405020304" pitchFamily="18" charset="0"/>
                </a:rPr>
                <a:t>Rho</a:t>
              </a:r>
              <a:r>
                <a:rPr lang="en-US" sz="1200" b="1" i="1" baseline="30000" dirty="0">
                  <a:latin typeface="Times New Roman" panose="02020603050405020304" pitchFamily="18" charset="0"/>
                  <a:ea typeface="+mn-lt"/>
                  <a:cs typeface="Times New Roman" panose="02020603050405020304" pitchFamily="18" charset="0"/>
                </a:rPr>
                <a:t>P23H+/-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95675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non McNamee</dc:creator>
  <cp:lastModifiedBy>Shannon McNamee</cp:lastModifiedBy>
  <cp:revision>1</cp:revision>
  <dcterms:created xsi:type="dcterms:W3CDTF">2023-07-31T15:28:16Z</dcterms:created>
  <dcterms:modified xsi:type="dcterms:W3CDTF">2023-07-31T15:29:03Z</dcterms:modified>
</cp:coreProperties>
</file>